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06" d="100"/>
          <a:sy n="106" d="100"/>
        </p:scale>
        <p:origin x="756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27868A8-70AE-33CB-A7A1-62644A58C29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E532F003-4A0F-77E7-F473-ED3E5BB3FFE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2D7FF54-62E1-BA0A-53B0-738560493F9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CA0766-A4B2-42FC-BB0A-A4BE312CCA23}" type="datetimeFigureOut">
              <a:rPr lang="en-US" smtClean="0"/>
              <a:t>6/7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7A3AEC1-801B-5281-7460-FB0866F896B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12C65F2-1729-0C71-E31B-A388F09BB58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C241DB-3F2C-4BE1-A440-694FC93288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291749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7AE5A52-90E7-5450-CA47-C7E2C96B5B0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70F1E9B-0856-8DBA-5272-008D602CA5A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AF6DE73-A8FD-04C8-0EB2-58C3DEAA4E7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CA0766-A4B2-42FC-BB0A-A4BE312CCA23}" type="datetimeFigureOut">
              <a:rPr lang="en-US" smtClean="0"/>
              <a:t>6/7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10B8E26-E97E-A2F1-7CA8-67699971335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08F70C0-26D3-5247-CB30-3254029187E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C241DB-3F2C-4BE1-A440-694FC93288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68232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500ABAF1-F968-2D4B-BB22-C916490F77A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8646716-FBA2-1290-9AE0-6646AA0B72F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8E97C7E-F55C-118B-D714-8A787C3030C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CA0766-A4B2-42FC-BB0A-A4BE312CCA23}" type="datetimeFigureOut">
              <a:rPr lang="en-US" smtClean="0"/>
              <a:t>6/7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27ECEBB-872A-52DB-C91E-628E92D7E5C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2EBCEDE-6296-AED4-63C7-62FFD3C0D51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C241DB-3F2C-4BE1-A440-694FC93288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785509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9449060-9302-10FC-247E-CDA21347430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F85071C-A217-9F3F-5656-7E00691C5E1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D3945BD-101C-DA60-47C1-FCF5FB73334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CA0766-A4B2-42FC-BB0A-A4BE312CCA23}" type="datetimeFigureOut">
              <a:rPr lang="en-US" smtClean="0"/>
              <a:t>6/7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6D77B3F-A316-216B-8BF5-C0251633074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3110D5F-E212-18FE-3FA8-C2873BF33F4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C241DB-3F2C-4BE1-A440-694FC93288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3411577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9D77863-663E-0450-0E02-030537485A6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7443ACD-2098-E856-C08A-7C9FD85ED58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B62638F-B59D-3AD0-1E38-C853FC1CA74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CA0766-A4B2-42FC-BB0A-A4BE312CCA23}" type="datetimeFigureOut">
              <a:rPr lang="en-US" smtClean="0"/>
              <a:t>6/7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3DF2800-125A-B759-40DD-1EA3633464A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6766642-0F60-4144-EF4E-60FCBE1857A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C241DB-3F2C-4BE1-A440-694FC93288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3126215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E3DCBF5-5794-B587-0DBE-C802F3457F0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B21D9BA-6319-EE9C-3C32-49A693CFCC7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B9C63E8-D612-A07B-D3BA-ECC83FA11B1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E3CF2E4-9169-02CF-EBF9-F3C6149F20F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CA0766-A4B2-42FC-BB0A-A4BE312CCA23}" type="datetimeFigureOut">
              <a:rPr lang="en-US" smtClean="0"/>
              <a:t>6/7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B88AAE4-C8F3-EA1F-D4E7-3EE18841A44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BBD664F-EE47-2768-2A2A-02F85C12766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C241DB-3F2C-4BE1-A440-694FC93288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5715262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C609EF3-095A-5AB4-B291-5311AEC58B6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B71977A-1B00-D206-D893-4BDFE328747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798AE58-66F4-CC9D-CC72-6144D8BCA99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1A6ACD08-0FCB-B267-5284-5348D8A849B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A18B91B4-55FB-B746-DAF7-F00C7CA918D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94171041-10BC-DC3B-B528-8463B4BE11F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CA0766-A4B2-42FC-BB0A-A4BE312CCA23}" type="datetimeFigureOut">
              <a:rPr lang="en-US" smtClean="0"/>
              <a:t>6/7/20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4C8F51AB-E9FC-67C4-49C3-1D09DC38537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68A49E09-4BC3-0C10-C4C1-BE4974DF044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C241DB-3F2C-4BE1-A440-694FC93288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0030626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198321A-0E90-09B6-7B34-160AB0AB18A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5DAF3FD5-BCDD-CC95-830D-EF3F18E59AB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CA0766-A4B2-42FC-BB0A-A4BE312CCA23}" type="datetimeFigureOut">
              <a:rPr lang="en-US" smtClean="0"/>
              <a:t>6/7/20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82477E99-105C-626E-8B75-68DDACACB5F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D8066015-8C08-1C6C-5181-BB9C12C8938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C241DB-3F2C-4BE1-A440-694FC93288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1962441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0E969A88-F911-DD08-74A7-3C0B40DC4F3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CA0766-A4B2-42FC-BB0A-A4BE312CCA23}" type="datetimeFigureOut">
              <a:rPr lang="en-US" smtClean="0"/>
              <a:t>6/7/20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E407E214-4FEA-9A04-1C7A-F4911730737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B6A3C8E9-C8EE-8785-F0A4-DDD07A1EDAA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C241DB-3F2C-4BE1-A440-694FC93288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1188696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01FE338-6C5C-3C53-8D27-CED914AB832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5333A95-994F-4EA3-290B-9FABB092D7D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8ABC8E6-AB58-6D93-C30C-0A8CA4E025C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403F33B-FEEF-08D7-91F6-E9395B8C9D4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CA0766-A4B2-42FC-BB0A-A4BE312CCA23}" type="datetimeFigureOut">
              <a:rPr lang="en-US" smtClean="0"/>
              <a:t>6/7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197996D-D3A9-7626-6750-B65EBF7E831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289C488-8322-310A-6909-58493275A27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C241DB-3F2C-4BE1-A440-694FC93288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594393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BFA45BD-B99E-0AED-1F0E-BCD856386CE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053D0454-9137-A324-B8EB-4AD0149D7A3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2E96183-304B-ED4C-F0E9-1D4E85AC424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CDA8F82-E3BD-B8D2-F828-235FD35014D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CA0766-A4B2-42FC-BB0A-A4BE312CCA23}" type="datetimeFigureOut">
              <a:rPr lang="en-US" smtClean="0"/>
              <a:t>6/7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7FCC85E-7B6F-2754-6C8C-0DB59605D1D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7CD9F6F-BE22-8F31-C506-76D9B7B4EE6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C241DB-3F2C-4BE1-A440-694FC93288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3229549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FC4154A1-B010-DA40-EEE7-1475429B068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A98AEA5-18E4-0E1F-6CF9-6A593F91CF4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3A621BC-C5C4-A85B-2D35-C0014381E01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33CA0766-A4B2-42FC-BB0A-A4BE312CCA23}" type="datetimeFigureOut">
              <a:rPr lang="en-US" smtClean="0"/>
              <a:t>6/7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58CD03C-006D-6AAF-39AD-F7112C6F80B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167469F-41ED-6265-BB3C-7565EE2DD0E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47C241DB-3F2C-4BE1-A440-694FC93288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8082392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10E58F0E-195D-BC8C-562F-14B6D8F74E6B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r="34465"/>
          <a:stretch/>
        </p:blipFill>
        <p:spPr>
          <a:xfrm>
            <a:off x="1775471" y="490688"/>
            <a:ext cx="8641057" cy="3993502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A59AA827-F5DA-6DF5-65A0-2A55E7F69B6A}"/>
              </a:ext>
            </a:extLst>
          </p:cNvPr>
          <p:cNvSpPr txBox="1"/>
          <p:nvPr/>
        </p:nvSpPr>
        <p:spPr>
          <a:xfrm>
            <a:off x="1624461" y="4484190"/>
            <a:ext cx="8943076" cy="126464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algn="just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1800" b="1" kern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l Figure 1. Cellpose segments images at a far greater rate than manual segmentation. </a:t>
            </a:r>
            <a:r>
              <a:rPr lang="en-US" sz="1800" kern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(a) Time taken to manually segment n number of cells. (b) Average time to segment 100 regions with SEM as error bars and average time in minutes located above bars. n = 9 images, 1863 nuclei (manual), 1981 nuclei (Cellpose). 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4420373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67</Words>
  <Application>Microsoft Office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Calibri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Riendeau, Jeremiah</dc:creator>
  <cp:lastModifiedBy>Riendeau, Jeremiah</cp:lastModifiedBy>
  <cp:revision>3</cp:revision>
  <dcterms:created xsi:type="dcterms:W3CDTF">2024-06-07T20:38:11Z</dcterms:created>
  <dcterms:modified xsi:type="dcterms:W3CDTF">2024-06-07T20:43:48Z</dcterms:modified>
</cp:coreProperties>
</file>